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B831D5-2519-4236-82F2-151FB641583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6ED9CD-C04C-4CCF-90FF-E19B86F49F2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210BDB-201C-45E1-987F-F34DD62CD30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F73447-AEAA-493A-8D9B-4E1A47D46CF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96C82C-A69A-4290-BE21-1140934B0C9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E0EFF4-60CA-42C2-9EB4-55C389BCB5E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C57535-C19B-4A57-BC29-784DFDB131B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42B823-25D9-48B0-9F8C-841A453BC45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7A4525-955F-4BE8-B1DF-319B6041079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2E336E-0B27-44A1-873A-7605E8CE222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BBF3D8-060E-41E4-82E7-1E6B106D6E0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574201-E891-427E-96EE-650925A87EB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846AE45-5401-4ED0-B678-437B7D4D6D40}" type="slidenum">
              <a:rPr b="0" lang="it-IT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4" descr=""/>
          <p:cNvPicPr/>
          <p:nvPr/>
        </p:nvPicPr>
        <p:blipFill>
          <a:blip r:embed="rId1"/>
          <a:stretch/>
        </p:blipFill>
        <p:spPr>
          <a:xfrm>
            <a:off x="1214280" y="2500200"/>
            <a:ext cx="2146320" cy="18608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42" name="Picture 12" descr=""/>
          <p:cNvPicPr/>
          <p:nvPr/>
        </p:nvPicPr>
        <p:blipFill>
          <a:blip r:embed="rId2"/>
          <a:stretch/>
        </p:blipFill>
        <p:spPr>
          <a:xfrm>
            <a:off x="3502080" y="549360"/>
            <a:ext cx="2141640" cy="18604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43" name="Picture 14" descr=""/>
          <p:cNvPicPr/>
          <p:nvPr/>
        </p:nvPicPr>
        <p:blipFill>
          <a:blip r:embed="rId3"/>
          <a:stretch/>
        </p:blipFill>
        <p:spPr>
          <a:xfrm>
            <a:off x="1214280" y="549360"/>
            <a:ext cx="2141640" cy="1860480"/>
          </a:xfrm>
          <a:prstGeom prst="rect">
            <a:avLst/>
          </a:prstGeom>
          <a:ln w="0">
            <a:noFill/>
          </a:ln>
        </p:spPr>
      </p:pic>
      <p:sp>
        <p:nvSpPr>
          <p:cNvPr id="44" name="CasellaDiTesto 16"/>
          <p:cNvSpPr/>
          <p:nvPr/>
        </p:nvSpPr>
        <p:spPr>
          <a:xfrm>
            <a:off x="1214280" y="549360"/>
            <a:ext cx="316080" cy="36828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CasellaDiTesto 17"/>
          <p:cNvSpPr/>
          <p:nvPr/>
        </p:nvSpPr>
        <p:spPr>
          <a:xfrm>
            <a:off x="1214280" y="2500200"/>
            <a:ext cx="316080" cy="36828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8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CasellaDiTesto 18"/>
          <p:cNvSpPr/>
          <p:nvPr/>
        </p:nvSpPr>
        <p:spPr>
          <a:xfrm>
            <a:off x="3500280" y="549360"/>
            <a:ext cx="316080" cy="36828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7" name="Picture 18" descr=""/>
          <p:cNvPicPr/>
          <p:nvPr/>
        </p:nvPicPr>
        <p:blipFill>
          <a:blip r:embed="rId4"/>
          <a:stretch/>
        </p:blipFill>
        <p:spPr>
          <a:xfrm>
            <a:off x="3500280" y="2500200"/>
            <a:ext cx="2143440" cy="18576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48" name="Rectangle 17"/>
          <p:cNvSpPr/>
          <p:nvPr/>
        </p:nvSpPr>
        <p:spPr>
          <a:xfrm>
            <a:off x="0" y="3240"/>
            <a:ext cx="720" cy="70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15876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CasellaDiTesto 16"/>
          <p:cNvSpPr/>
          <p:nvPr/>
        </p:nvSpPr>
        <p:spPr>
          <a:xfrm>
            <a:off x="3500280" y="2500200"/>
            <a:ext cx="316080" cy="36828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8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Connettore 1 19"/>
          <p:cNvSpPr/>
          <p:nvPr/>
        </p:nvSpPr>
        <p:spPr>
          <a:xfrm>
            <a:off x="5280120" y="714240"/>
            <a:ext cx="247680" cy="1800"/>
          </a:xfrm>
          <a:prstGeom prst="line">
            <a:avLst/>
          </a:prstGeom>
          <a:ln w="2844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Connettore 1 28"/>
          <p:cNvSpPr/>
          <p:nvPr/>
        </p:nvSpPr>
        <p:spPr>
          <a:xfrm>
            <a:off x="2976480" y="830160"/>
            <a:ext cx="247680" cy="1800"/>
          </a:xfrm>
          <a:prstGeom prst="line">
            <a:avLst/>
          </a:prstGeom>
          <a:ln w="2844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Connettore 1 29"/>
          <p:cNvSpPr/>
          <p:nvPr/>
        </p:nvSpPr>
        <p:spPr>
          <a:xfrm>
            <a:off x="5265720" y="2717640"/>
            <a:ext cx="249120" cy="1800"/>
          </a:xfrm>
          <a:prstGeom prst="line">
            <a:avLst/>
          </a:prstGeom>
          <a:ln w="2844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Connettore 1 30"/>
          <p:cNvSpPr/>
          <p:nvPr/>
        </p:nvSpPr>
        <p:spPr>
          <a:xfrm>
            <a:off x="2998800" y="2784600"/>
            <a:ext cx="247680" cy="1440"/>
          </a:xfrm>
          <a:prstGeom prst="line">
            <a:avLst/>
          </a:prstGeom>
          <a:ln w="2844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CasellaDiTesto 15"/>
          <p:cNvSpPr/>
          <p:nvPr/>
        </p:nvSpPr>
        <p:spPr>
          <a:xfrm>
            <a:off x="765000" y="4716360"/>
            <a:ext cx="5543640" cy="2710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600" spc="-1" strike="noStrike">
                <a:solidFill>
                  <a:srgbClr val="000000"/>
                </a:solidFill>
                <a:latin typeface="Arial"/>
              </a:rPr>
              <a:t>Additional Figure 1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 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Immunohistochemical controls for CXCR4 expression in feline mammary carcinoma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A.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 Negative control obtained by omitting the rabbit primary antibody against CXCR4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B.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 Negative control obtained by substituting the primary antibody with rabbit IgG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C.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 CXCR4 staining with rabbit anti-CXCR4 antibody (Sigma-Aldrich)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D.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 CXCR4 staining with rabbit anti-CXCR4 antibody (R&amp;D Systems)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Tissue images derived from a tubulopapillary carcinoma, bar = 25 </a:t>
            </a:r>
            <a:r>
              <a:rPr b="0" lang="en-GB" sz="12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m, original magnification 40X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4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11-21T09:54:13Z</dcterms:created>
  <dc:creator>FEDE</dc:creator>
  <dc:description/>
  <dc:language>en-US</dc:language>
  <cp:lastModifiedBy>Tullio Florio</cp:lastModifiedBy>
  <dcterms:modified xsi:type="dcterms:W3CDTF">2012-05-16T12:34:32Z</dcterms:modified>
  <cp:revision>41</cp:revision>
  <dc:subject/>
  <dc:title>Diapositiva 1</dc:title>
</cp:coreProperties>
</file>